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5" r:id="rId2"/>
  </p:sldIdLst>
  <p:sldSz cx="12192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1" d="100"/>
          <a:sy n="31" d="100"/>
        </p:scale>
        <p:origin x="200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32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67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322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391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270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061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620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838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825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7281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7346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411CE-82B7-4750-8234-5F170D4BEFA4}" type="datetimeFigureOut">
              <a:rPr lang="zh-CN" altLang="en-US" smtClean="0"/>
              <a:t>2021/6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D67F7-8660-4C0A-8BB1-394BF0C689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16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EE195C6-99D4-4DC1-B0FD-BC3934BD4CA0}"/>
              </a:ext>
            </a:extLst>
          </p:cNvPr>
          <p:cNvGrpSpPr/>
          <p:nvPr/>
        </p:nvGrpSpPr>
        <p:grpSpPr>
          <a:xfrm>
            <a:off x="593682" y="1507679"/>
            <a:ext cx="11004636" cy="7598221"/>
            <a:chOff x="593682" y="485998"/>
            <a:chExt cx="11004636" cy="5521771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6A3BF35-7758-431F-AF1E-087BC0A050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73" r="3581" b="9715"/>
            <a:stretch/>
          </p:blipFill>
          <p:spPr>
            <a:xfrm>
              <a:off x="7220572" y="796640"/>
              <a:ext cx="2196706" cy="1479597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331C900-35DB-43C0-9294-95EDE1B0BA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51" r="4150" b="9242"/>
            <a:stretch/>
          </p:blipFill>
          <p:spPr>
            <a:xfrm>
              <a:off x="650832" y="777590"/>
              <a:ext cx="2176215" cy="1479597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044066F-309F-424C-9BEC-008F4C4BE552}"/>
                </a:ext>
              </a:extLst>
            </p:cNvPr>
            <p:cNvSpPr txBox="1"/>
            <p:nvPr/>
          </p:nvSpPr>
          <p:spPr>
            <a:xfrm>
              <a:off x="1129969" y="488884"/>
              <a:ext cx="1518566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RCA</a:t>
              </a:r>
              <a:r>
                <a:rPr lang="en-US" altLang="zh-CN" b="1" dirty="0"/>
                <a:t>  </a:t>
              </a:r>
              <a:r>
                <a:rPr lang="zh-CN" altLang="en-US" b="1" dirty="0"/>
                <a:t>NK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2B97162C-9DE6-4AE1-8E49-3827A462C4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232" r="3964" b="9351"/>
            <a:stretch/>
          </p:blipFill>
          <p:spPr>
            <a:xfrm>
              <a:off x="2855797" y="796640"/>
              <a:ext cx="2185493" cy="1479597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4D7A4757-EE07-414B-9527-6217551C1F0B}"/>
                </a:ext>
              </a:extLst>
            </p:cNvPr>
            <p:cNvSpPr txBox="1"/>
            <p:nvPr/>
          </p:nvSpPr>
          <p:spPr>
            <a:xfrm>
              <a:off x="3176510" y="488884"/>
              <a:ext cx="1679853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RCA</a:t>
              </a:r>
              <a:r>
                <a:rPr lang="en-US" altLang="zh-CN" b="1" dirty="0"/>
                <a:t>  </a:t>
              </a:r>
              <a:r>
                <a:rPr lang="zh-CN" altLang="en-US" b="1" dirty="0"/>
                <a:t>Treg+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3DFE79C3-2B0B-4D85-8B0E-DCEA18CED6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66" r="3710" b="9743"/>
            <a:stretch/>
          </p:blipFill>
          <p:spPr>
            <a:xfrm>
              <a:off x="5034876" y="796640"/>
              <a:ext cx="2196706" cy="1484965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8EBA3CE-E2E1-4A22-B82F-16917596240E}"/>
                </a:ext>
              </a:extLst>
            </p:cNvPr>
            <p:cNvSpPr txBox="1"/>
            <p:nvPr/>
          </p:nvSpPr>
          <p:spPr>
            <a:xfrm>
              <a:off x="5497139" y="488884"/>
              <a:ext cx="1648239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RCA</a:t>
              </a:r>
              <a:r>
                <a:rPr lang="en-US" altLang="zh-CN" b="1" dirty="0"/>
                <a:t>  </a:t>
              </a:r>
              <a:r>
                <a:rPr lang="zh-CN" altLang="en-US" b="1" dirty="0"/>
                <a:t>Treg+</a:t>
              </a:r>
              <a:r>
                <a:rPr lang="en-US" altLang="zh-CN" b="1" dirty="0"/>
                <a:t>OS</a:t>
              </a:r>
              <a:endParaRPr lang="zh-CN" altLang="en-US" b="1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C13219F-F5DF-48CB-8BC4-0A5FD05A9C59}"/>
                </a:ext>
              </a:extLst>
            </p:cNvPr>
            <p:cNvSpPr txBox="1"/>
            <p:nvPr/>
          </p:nvSpPr>
          <p:spPr>
            <a:xfrm>
              <a:off x="7645357" y="488884"/>
              <a:ext cx="1648239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RCA</a:t>
              </a:r>
              <a:r>
                <a:rPr lang="en-US" altLang="zh-CN" b="1" dirty="0"/>
                <a:t>  </a:t>
              </a:r>
              <a:r>
                <a:rPr lang="zh-CN" altLang="en-US" b="1" dirty="0"/>
                <a:t>Treg</a:t>
              </a:r>
              <a:r>
                <a:rPr lang="en-US" altLang="zh-CN" b="1" dirty="0"/>
                <a:t>-OS</a:t>
              </a:r>
              <a:endParaRPr lang="zh-CN" altLang="en-US" b="1" dirty="0"/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08A40F60-BF8B-41E0-BD88-5467AC4BA3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78" r="4073" b="9470"/>
            <a:stretch/>
          </p:blipFill>
          <p:spPr>
            <a:xfrm>
              <a:off x="9417278" y="787726"/>
              <a:ext cx="2176216" cy="1488511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F30EA15E-1B6C-433C-A20B-51E01AE0C0AC}"/>
                </a:ext>
              </a:extLst>
            </p:cNvPr>
            <p:cNvSpPr txBox="1"/>
            <p:nvPr/>
          </p:nvSpPr>
          <p:spPr>
            <a:xfrm>
              <a:off x="9830851" y="485998"/>
              <a:ext cx="1534994" cy="3013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UAD  NK-OS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B5BC4BA-9FE5-4C15-8F5C-822419E87575}"/>
                </a:ext>
              </a:extLst>
            </p:cNvPr>
            <p:cNvSpPr txBox="1"/>
            <p:nvPr/>
          </p:nvSpPr>
          <p:spPr>
            <a:xfrm>
              <a:off x="926511" y="2353373"/>
              <a:ext cx="1878716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LCA  CD8+T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D9995F23-5C1D-4C48-A47B-3265AD6C85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67" r="3718" b="9619"/>
            <a:stretch/>
          </p:blipFill>
          <p:spPr>
            <a:xfrm>
              <a:off x="593682" y="2642741"/>
              <a:ext cx="2246068" cy="1514579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2A38F78D-EF61-41E4-A48F-1D907ADC84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372" r="4014" b="9713"/>
            <a:stretch/>
          </p:blipFill>
          <p:spPr>
            <a:xfrm>
              <a:off x="2855798" y="2669539"/>
              <a:ext cx="2185493" cy="1485542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5B0D4F68-1C1F-4624-ABF6-9B04A5B6362B}"/>
                </a:ext>
              </a:extLst>
            </p:cNvPr>
            <p:cNvSpPr txBox="1"/>
            <p:nvPr/>
          </p:nvSpPr>
          <p:spPr>
            <a:xfrm>
              <a:off x="2764190" y="2353373"/>
              <a:ext cx="2537871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LCA  Macrophage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BA6431EF-BCC8-4CC8-8ECC-C9061B55CF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13" r="3720" b="9119"/>
            <a:stretch/>
          </p:blipFill>
          <p:spPr>
            <a:xfrm>
              <a:off x="5041290" y="2653784"/>
              <a:ext cx="2176064" cy="1475419"/>
            </a:xfrm>
            <a:prstGeom prst="rect">
              <a:avLst/>
            </a:prstGeom>
          </p:spPr>
        </p:pic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F9AD4C5-C660-493C-813D-B028732CC814}"/>
                </a:ext>
              </a:extLst>
            </p:cNvPr>
            <p:cNvSpPr txBox="1"/>
            <p:nvPr/>
          </p:nvSpPr>
          <p:spPr>
            <a:xfrm>
              <a:off x="5071104" y="2353373"/>
              <a:ext cx="2366653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BLCA  Macrophage-</a:t>
              </a:r>
              <a:r>
                <a:rPr lang="en-US" altLang="zh-CN" b="1" dirty="0"/>
                <a:t>OS</a:t>
              </a:r>
              <a:endParaRPr lang="zh-CN" altLang="en-US" b="1" dirty="0"/>
            </a:p>
          </p:txBody>
        </p: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814FB66E-C3D0-49A7-A5EB-7E3DB814DB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973" r="3329" b="9742"/>
            <a:stretch/>
          </p:blipFill>
          <p:spPr>
            <a:xfrm>
              <a:off x="7220572" y="2648416"/>
              <a:ext cx="2176064" cy="1468727"/>
            </a:xfrm>
            <a:prstGeom prst="rect">
              <a:avLst/>
            </a:prstGeom>
          </p:spPr>
        </p:pic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E8ADA0F-2D82-49EA-81DB-8E2ABC0FBA37}"/>
                </a:ext>
              </a:extLst>
            </p:cNvPr>
            <p:cNvSpPr txBox="1"/>
            <p:nvPr/>
          </p:nvSpPr>
          <p:spPr>
            <a:xfrm>
              <a:off x="9857552" y="2347989"/>
              <a:ext cx="1682150" cy="3063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KRIC  Treg</a:t>
              </a:r>
              <a:r>
                <a:rPr lang="en-US" altLang="zh-CN" b="1" dirty="0"/>
                <a:t>-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60122624-D378-45B9-86D1-C819BCD5D8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28" r="4101" b="10002"/>
            <a:stretch/>
          </p:blipFill>
          <p:spPr>
            <a:xfrm>
              <a:off x="9389534" y="2633185"/>
              <a:ext cx="2176216" cy="147295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4D28874-4302-4801-9C26-ECA9B06E14EF}"/>
                </a:ext>
              </a:extLst>
            </p:cNvPr>
            <p:cNvSpPr txBox="1"/>
            <p:nvPr/>
          </p:nvSpPr>
          <p:spPr>
            <a:xfrm>
              <a:off x="7683639" y="2347989"/>
              <a:ext cx="1682150" cy="3063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KRIC  Treg+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BB454B25-E8F3-48F5-8067-27720AC919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214" r="3922" b="9661"/>
            <a:stretch/>
          </p:blipFill>
          <p:spPr>
            <a:xfrm>
              <a:off x="650832" y="4521981"/>
              <a:ext cx="2178598" cy="1478537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E25C71D-3886-44EB-B9CC-F0DDF4891C0E}"/>
                </a:ext>
              </a:extLst>
            </p:cNvPr>
            <p:cNvSpPr txBox="1"/>
            <p:nvPr/>
          </p:nvSpPr>
          <p:spPr>
            <a:xfrm>
              <a:off x="957765" y="4255184"/>
              <a:ext cx="1903533" cy="3045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IHC  CD4+T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283D3B10-28F7-45D2-B4CC-A742D448DE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877" r="3996" b="9892"/>
            <a:stretch/>
          </p:blipFill>
          <p:spPr>
            <a:xfrm>
              <a:off x="2839751" y="4521981"/>
              <a:ext cx="2177755" cy="1471607"/>
            </a:xfrm>
            <a:prstGeom prst="rect">
              <a:avLst/>
            </a:prstGeom>
          </p:spPr>
        </p:pic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C185E9F-668C-49BE-9E03-73B7CEA71EB9}"/>
                </a:ext>
              </a:extLst>
            </p:cNvPr>
            <p:cNvSpPr txBox="1"/>
            <p:nvPr/>
          </p:nvSpPr>
          <p:spPr>
            <a:xfrm>
              <a:off x="3197868" y="4255184"/>
              <a:ext cx="1903533" cy="3045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IHC  CD</a:t>
              </a:r>
              <a:r>
                <a:rPr lang="en-US" altLang="zh-CN" b="1" dirty="0"/>
                <a:t>8</a:t>
              </a:r>
              <a:r>
                <a:rPr lang="zh-CN" altLang="en-US" b="1" dirty="0"/>
                <a:t>+T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1E8B288E-FE38-429D-A5F6-09B2E3F251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7855" r="3797" b="9366"/>
            <a:stretch/>
          </p:blipFill>
          <p:spPr>
            <a:xfrm>
              <a:off x="5053263" y="4550552"/>
              <a:ext cx="2146839" cy="1457217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5305AB1D-A0BF-4C23-B7E3-10847985ED4D}"/>
                </a:ext>
              </a:extLst>
            </p:cNvPr>
            <p:cNvSpPr txBox="1"/>
            <p:nvPr/>
          </p:nvSpPr>
          <p:spPr>
            <a:xfrm>
              <a:off x="5144882" y="4259654"/>
              <a:ext cx="2366653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IHC  Macrophage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DC370A70-F191-4765-96CD-B9A1642C68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58" r="3507" b="9276"/>
            <a:stretch/>
          </p:blipFill>
          <p:spPr>
            <a:xfrm>
              <a:off x="7209247" y="4523656"/>
              <a:ext cx="2177756" cy="1482722"/>
            </a:xfrm>
            <a:prstGeom prst="rect">
              <a:avLst/>
            </a:prstGeom>
          </p:spPr>
        </p:pic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B50854DD-389A-4D41-BEC7-CF701C6206DE}"/>
                </a:ext>
              </a:extLst>
            </p:cNvPr>
            <p:cNvSpPr txBox="1"/>
            <p:nvPr/>
          </p:nvSpPr>
          <p:spPr>
            <a:xfrm>
              <a:off x="7824956" y="4259654"/>
              <a:ext cx="1558084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IHC  </a:t>
              </a:r>
              <a:r>
                <a:rPr lang="en-US" altLang="zh-CN" b="1" dirty="0"/>
                <a:t>NK</a:t>
              </a:r>
              <a:r>
                <a:rPr lang="zh-CN" altLang="en-US" b="1" dirty="0"/>
                <a:t>-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007F2514-88DF-4530-B18A-18898EACE4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250" r="4187" b="9265"/>
            <a:stretch/>
          </p:blipFill>
          <p:spPr>
            <a:xfrm>
              <a:off x="9415902" y="4523656"/>
              <a:ext cx="2155977" cy="1469932"/>
            </a:xfrm>
            <a:prstGeom prst="rect">
              <a:avLst/>
            </a:prstGeom>
          </p:spPr>
        </p:pic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7DD1C06E-BC6F-4098-AB04-5DE17E0362DE}"/>
                </a:ext>
              </a:extLst>
            </p:cNvPr>
            <p:cNvSpPr txBox="1"/>
            <p:nvPr/>
          </p:nvSpPr>
          <p:spPr>
            <a:xfrm>
              <a:off x="9882334" y="4259654"/>
              <a:ext cx="1715984" cy="2955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b="1" dirty="0"/>
                <a:t>LIHC  Treg+</a:t>
              </a:r>
              <a:r>
                <a:rPr lang="en-US" altLang="zh-CN" b="1" dirty="0"/>
                <a:t>D</a:t>
              </a:r>
              <a:r>
                <a:rPr lang="zh-CN" altLang="en-US" b="1" dirty="0"/>
                <a:t>FS</a:t>
              </a: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0F422929-E34A-4220-A222-B04A7C4C07D7}"/>
              </a:ext>
            </a:extLst>
          </p:cNvPr>
          <p:cNvSpPr txBox="1"/>
          <p:nvPr/>
        </p:nvSpPr>
        <p:spPr>
          <a:xfrm>
            <a:off x="268834" y="521870"/>
            <a:ext cx="16374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2800" b="1"/>
            </a:lvl1pPr>
          </a:lstStyle>
          <a:p>
            <a:r>
              <a:rPr lang="en-US" altLang="zh-CN" dirty="0"/>
              <a:t>S-Figure 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64427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0</Words>
  <Application>Microsoft Office PowerPoint</Application>
  <PresentationFormat>自定义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春秋时代 李家秋</dc:creator>
  <cp:lastModifiedBy>春秋时代 李家秋</cp:lastModifiedBy>
  <cp:revision>2</cp:revision>
  <dcterms:created xsi:type="dcterms:W3CDTF">2021-06-05T14:42:30Z</dcterms:created>
  <dcterms:modified xsi:type="dcterms:W3CDTF">2021-06-05T14:54:24Z</dcterms:modified>
</cp:coreProperties>
</file>